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032" autoAdjust="0"/>
    <p:restoredTop sz="94660"/>
  </p:normalViewPr>
  <p:slideViewPr>
    <p:cSldViewPr snapToGrid="0">
      <p:cViewPr varScale="1">
        <p:scale>
          <a:sx n="47" d="100"/>
          <a:sy n="47" d="100"/>
        </p:scale>
        <p:origin x="43" y="3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450962-54BC-4B40-933E-19571EE21C9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3BDD050-1FFA-30B2-31E4-05D48597B63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76619F-46B1-805F-B795-E7D8B4CC4B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D980E4-3A16-473D-9D5B-DBB994731B8D}" type="datetimeFigureOut">
              <a:rPr lang="en-US" smtClean="0"/>
              <a:t>4/2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BB5758-2BCD-1683-AAB0-727AE1613D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86EF29-1832-C491-B079-EF963AD44A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305166-4123-4856-B1F0-36056DF941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30924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9A9E00-54CC-FD2C-11F8-24CB0159F0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69235C4-58F5-88B2-3CAB-AEB09DF29DC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BB25D2-5830-D7B2-613E-1447985A90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D980E4-3A16-473D-9D5B-DBB994731B8D}" type="datetimeFigureOut">
              <a:rPr lang="en-US" smtClean="0"/>
              <a:t>4/2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D38919-0E59-E8C9-8210-E8B1334241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9A09E5-F731-554E-52D0-36943156B4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305166-4123-4856-B1F0-36056DF941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16203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DDEF022-13A2-0B36-1007-5DAB0453298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10033B9-EBC4-9552-7C1B-908B02C2AC3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FA9B3E-95FF-CB23-910C-591C0C900C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D980E4-3A16-473D-9D5B-DBB994731B8D}" type="datetimeFigureOut">
              <a:rPr lang="en-US" smtClean="0"/>
              <a:t>4/2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48FAEC-17AE-DFCE-A72B-7148159EA9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8575B3-314C-F048-C647-BA20C35200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305166-4123-4856-B1F0-36056DF941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7558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74BCFD-16F5-297F-742C-4F246DAA93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814861D-5CAD-6111-E498-C909974D9FC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1F64EC3-E6BD-9495-EDCA-B25A780F67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D980E4-3A16-473D-9D5B-DBB994731B8D}" type="datetimeFigureOut">
              <a:rPr lang="en-US" smtClean="0"/>
              <a:t>4/2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F24C1E-6E05-7472-E54C-9A59D9C174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A330AC-3D52-AE8B-AB60-EDFD7002CB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305166-4123-4856-B1F0-36056DF941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12141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C25C38-DA1E-E72E-29C3-C901F6E1C4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2C21A6D-6DC8-F89D-6095-48AF5B68AB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959761-66A7-B677-24C4-0F7E9C9DBF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D980E4-3A16-473D-9D5B-DBB994731B8D}" type="datetimeFigureOut">
              <a:rPr lang="en-US" smtClean="0"/>
              <a:t>4/2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60D6B7-1715-816F-5B73-2925CA3DEB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BB9282-0BDB-09A6-F7E8-8306026287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305166-4123-4856-B1F0-36056DF941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07930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EB0270-77AA-76B4-A3B7-E4F2321118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C5FFC92-9BE7-0408-3EF6-9151B3AF31F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9C6A542-9FF0-6DBA-539E-AE0608C0FA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5D7DAA6-8520-4645-165B-F831480B95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D980E4-3A16-473D-9D5B-DBB994731B8D}" type="datetimeFigureOut">
              <a:rPr lang="en-US" smtClean="0"/>
              <a:t>4/26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3E4C180-8FE7-F5EE-540D-97007B8178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36B02E6-47E0-A962-064F-0E086EC2D7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305166-4123-4856-B1F0-36056DF941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69985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B17EBC-5A7C-AAE0-D297-780052690F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6EAA681-8FE1-2CA5-6771-B2CB9D0EE9E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2CC72A8-E4D1-5FC2-DAA1-5E1B661454F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4695A92-59D0-F016-634B-61CF1E683A0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AFF86C3-D210-C026-EFEC-22D1FB15277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9C1A9C2-218A-B1B1-AE94-AED9B0798B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D980E4-3A16-473D-9D5B-DBB994731B8D}" type="datetimeFigureOut">
              <a:rPr lang="en-US" smtClean="0"/>
              <a:t>4/26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F1D31CC-5E9C-0E60-5787-6BF6BAB717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5F3ABEB-4A5D-60AC-4356-7A77089BBE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305166-4123-4856-B1F0-36056DF941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48253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29DF20-2574-D63A-6F34-6871D28EF8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24FFCAB-FF34-AEF1-B2A6-A45303A403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D980E4-3A16-473D-9D5B-DBB994731B8D}" type="datetimeFigureOut">
              <a:rPr lang="en-US" smtClean="0"/>
              <a:t>4/26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1E0A576-BF9E-5D35-F006-6FD9DEBFB7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4DB24C1-C77B-42D4-1D7E-30BD7D2D2A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305166-4123-4856-B1F0-36056DF941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97972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67B910D-2959-2891-B881-1BBE8C86D5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D980E4-3A16-473D-9D5B-DBB994731B8D}" type="datetimeFigureOut">
              <a:rPr lang="en-US" smtClean="0"/>
              <a:t>4/26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41B2912-A78C-7C3E-122B-985CF7B333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E11F58D-22B3-02FE-F4A7-C4D36B8927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305166-4123-4856-B1F0-36056DF941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96092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0F420F-48B2-BB0B-886E-66170A6375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DF630ED-A1AD-57A3-C906-DCD6DB56424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E5C0F08-03E3-28E7-6B3A-0CA845BC316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5FE6224-E5F8-DC8F-3871-518BB94390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D980E4-3A16-473D-9D5B-DBB994731B8D}" type="datetimeFigureOut">
              <a:rPr lang="en-US" smtClean="0"/>
              <a:t>4/26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03CAB8-9F6B-4141-15EA-0ECCD47F07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89B21AC-8BF9-9007-2E39-BEF107C7B9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305166-4123-4856-B1F0-36056DF941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80223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A673B9-E9B5-2E31-6F09-864A9EDF1A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E37C32F-D5BB-6B66-8151-B86B9D1E131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0FCDF1E-97FE-CCDD-E0EF-04C27A6A431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C5DEEB1-B80C-F9E6-ADA7-7D56AC36AD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D980E4-3A16-473D-9D5B-DBB994731B8D}" type="datetimeFigureOut">
              <a:rPr lang="en-US" smtClean="0"/>
              <a:t>4/26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AAC1A9C-2655-DD6F-EFA7-D450803A95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D37BA71-20AE-A7F5-D19F-D2EE440FCC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305166-4123-4856-B1F0-36056DF941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01565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16431E0-6A01-334F-3ECB-71318870A6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69B9A40-39F2-0E50-81B7-1546E5BD80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6F6250-C46C-7A7A-498B-EC109594457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DD980E4-3A16-473D-9D5B-DBB994731B8D}" type="datetimeFigureOut">
              <a:rPr lang="en-US" smtClean="0"/>
              <a:t>4/2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6FC649-704A-1D22-DCEA-6141A1EDB69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58CFA80-99D1-2ABF-A936-DA5E88BA907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F305166-4123-4856-B1F0-36056DF941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10483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diagram of a company&#10;&#10;Description automatically generated">
            <a:extLst>
              <a:ext uri="{FF2B5EF4-FFF2-40B4-BE49-F238E27FC236}">
                <a16:creationId xmlns:a16="http://schemas.microsoft.com/office/drawing/2014/main" id="{B71FCE6C-2367-AD7C-BC59-AAE48C0569C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65393" y="1240972"/>
            <a:ext cx="8018199" cy="368345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2AAC828-DE41-EB89-46FA-E693A84A3EDD}"/>
              </a:ext>
            </a:extLst>
          </p:cNvPr>
          <p:cNvSpPr txBox="1"/>
          <p:nvPr/>
        </p:nvSpPr>
        <p:spPr>
          <a:xfrm>
            <a:off x="1877676" y="6211669"/>
            <a:ext cx="925574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000000"/>
                </a:solidFill>
                <a:latin typeface="Calibri" panose="020F0502020204030204" pitchFamily="34" charset="0"/>
              </a:rPr>
              <a:t>Supplementary Figure 3 – Breakdown of MRI-based modified Snyder Classifications of RC tears pre- and post- autologous BMC treatment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</a:rPr>
              <a:t>. Articular surface (A), bursal surface (B), complete tear (C), and tear severity (I-IV).</a:t>
            </a:r>
          </a:p>
          <a:p>
            <a:r>
              <a:rPr lang="en-US" sz="1200" dirty="0">
                <a:solidFill>
                  <a:srgbClr val="000000"/>
                </a:solidFill>
                <a:latin typeface="Calibri" panose="020F0502020204030204" pitchFamily="34" charset="0"/>
              </a:rPr>
              <a:t> </a:t>
            </a:r>
            <a:endParaRPr lang="en-US" sz="1200" dirty="0">
              <a:solidFill>
                <a:prstClr val="black"/>
              </a:solidFill>
              <a:latin typeface="Calibri" panose="020F0502020204030204"/>
            </a:endParaRPr>
          </a:p>
        </p:txBody>
      </p:sp>
    </p:spTree>
    <p:extLst>
      <p:ext uri="{BB962C8B-B14F-4D97-AF65-F5344CB8AC3E}">
        <p14:creationId xmlns:p14="http://schemas.microsoft.com/office/powerpoint/2010/main" val="15192278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42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hren Dodson</dc:creator>
  <cp:lastModifiedBy>Ehren Dodson</cp:lastModifiedBy>
  <cp:revision>1</cp:revision>
  <dcterms:created xsi:type="dcterms:W3CDTF">2024-04-26T14:43:47Z</dcterms:created>
  <dcterms:modified xsi:type="dcterms:W3CDTF">2024-04-26T14:47:05Z</dcterms:modified>
</cp:coreProperties>
</file>